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2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1893"/>
    <a:srgbClr val="942093"/>
    <a:srgbClr val="9437FF"/>
    <a:srgbClr val="FF9300"/>
    <a:srgbClr val="929292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404"/>
    <p:restoredTop sz="96310"/>
  </p:normalViewPr>
  <p:slideViewPr>
    <p:cSldViewPr snapToGrid="0">
      <p:cViewPr varScale="1">
        <p:scale>
          <a:sx n="103" d="100"/>
          <a:sy n="103" d="100"/>
        </p:scale>
        <p:origin x="484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6A4D8E-4468-8940-8495-075939C632A2}" type="datetimeFigureOut">
              <a:rPr lang="en-US" smtClean="0"/>
              <a:t>9/16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EE1239-6483-EE4F-A3E6-E515071B15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7593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07075A-7CC3-C348-8DCC-6C7A958E476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427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026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6356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175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5280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62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317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9112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717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747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312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499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6078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47BA3225-698B-85A7-1F03-AEAAD581FB90}"/>
              </a:ext>
            </a:extLst>
          </p:cNvPr>
          <p:cNvSpPr txBox="1"/>
          <p:nvPr/>
        </p:nvSpPr>
        <p:spPr>
          <a:xfrm>
            <a:off x="68468" y="1589"/>
            <a:ext cx="19487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2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E9EBCC98-97B1-BB6E-FB44-C0183CE3120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95872" y="2947244"/>
            <a:ext cx="2629614" cy="2283274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C0F138B0-9706-91FB-85B3-6E562479054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16880" y="485804"/>
            <a:ext cx="2547726" cy="2212172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69130166-9FCC-D448-0D1B-20E4DFAD958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16880" y="2942272"/>
            <a:ext cx="2629613" cy="2283274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CE8C2EAB-A13A-AB55-A65C-416E79AD978E}"/>
              </a:ext>
            </a:extLst>
          </p:cNvPr>
          <p:cNvSpPr txBox="1"/>
          <p:nvPr/>
        </p:nvSpPr>
        <p:spPr>
          <a:xfrm>
            <a:off x="1802004" y="370922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TLR1/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F665ABE-4A73-664C-CF66-72A5E65A2856}"/>
              </a:ext>
            </a:extLst>
          </p:cNvPr>
          <p:cNvSpPr txBox="1"/>
          <p:nvPr/>
        </p:nvSpPr>
        <p:spPr>
          <a:xfrm>
            <a:off x="4490520" y="370921"/>
            <a:ext cx="5774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TLR4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45ED0A8-8DF9-DB3A-C2D9-92D7812FC34F}"/>
              </a:ext>
            </a:extLst>
          </p:cNvPr>
          <p:cNvSpPr txBox="1"/>
          <p:nvPr/>
        </p:nvSpPr>
        <p:spPr>
          <a:xfrm>
            <a:off x="4323006" y="2790870"/>
            <a:ext cx="9124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Symbol" pitchFamily="2" charset="2"/>
              </a:rPr>
              <a:t>a</a:t>
            </a:r>
            <a:r>
              <a:rPr lang="en-US" sz="1400" b="1" dirty="0"/>
              <a:t>CD3/28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DD4C17CA-B62C-DDC2-FFB2-F604EF736669}"/>
              </a:ext>
            </a:extLst>
          </p:cNvPr>
          <p:cNvGrpSpPr/>
          <p:nvPr/>
        </p:nvGrpSpPr>
        <p:grpSpPr>
          <a:xfrm>
            <a:off x="895872" y="556940"/>
            <a:ext cx="2629614" cy="2166875"/>
            <a:chOff x="147705" y="587914"/>
            <a:chExt cx="1790271" cy="1554480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F60C67F4-A649-7EF1-89D9-18757F94657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47705" y="587914"/>
              <a:ext cx="1790271" cy="1554480"/>
            </a:xfrm>
            <a:prstGeom prst="rect">
              <a:avLst/>
            </a:prstGeom>
          </p:spPr>
        </p:pic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3810C73D-5CB7-047C-EC48-0233AEBAEAA9}"/>
                </a:ext>
              </a:extLst>
            </p:cNvPr>
            <p:cNvSpPr txBox="1"/>
            <p:nvPr/>
          </p:nvSpPr>
          <p:spPr>
            <a:xfrm>
              <a:off x="835156" y="819322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solidFill>
                    <a:srgbClr val="FF2600"/>
                  </a:solidFill>
                </a:rPr>
                <a:t>*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2D2340E7-9E50-5BD9-8B5A-8466B910720E}"/>
              </a:ext>
            </a:extLst>
          </p:cNvPr>
          <p:cNvSpPr txBox="1"/>
          <p:nvPr/>
        </p:nvSpPr>
        <p:spPr>
          <a:xfrm>
            <a:off x="132329" y="5505914"/>
            <a:ext cx="659334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 (related to Figure 2). 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azard ratios -/+ 95% confidence interval of cytokine induction (fold mock control) for each stimulation type from a Cox proportional hazards model; (*) indicates p&lt;0.05. 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AB10123-D932-D96E-EC2E-229E838F5175}"/>
              </a:ext>
            </a:extLst>
          </p:cNvPr>
          <p:cNvSpPr txBox="1"/>
          <p:nvPr/>
        </p:nvSpPr>
        <p:spPr>
          <a:xfrm>
            <a:off x="1905625" y="2790870"/>
            <a:ext cx="6619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MDA5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C023676-FC74-85DB-1D5F-1482A3132F29}"/>
              </a:ext>
            </a:extLst>
          </p:cNvPr>
          <p:cNvSpPr txBox="1"/>
          <p:nvPr/>
        </p:nvSpPr>
        <p:spPr>
          <a:xfrm>
            <a:off x="2107174" y="5228915"/>
            <a:ext cx="30479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Hazard Ratio -/+ 95% Confidence Interval</a:t>
            </a:r>
          </a:p>
        </p:txBody>
      </p:sp>
    </p:spTree>
    <p:extLst>
      <p:ext uri="{BB962C8B-B14F-4D97-AF65-F5344CB8AC3E}">
        <p14:creationId xmlns:p14="http://schemas.microsoft.com/office/powerpoint/2010/main" val="2899441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365</TotalTime>
  <Words>55</Words>
  <Application>Microsoft Macintosh PowerPoint</Application>
  <PresentationFormat>Letter Paper (8.5x11 in)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Brown</dc:creator>
  <cp:lastModifiedBy>Michael Brown</cp:lastModifiedBy>
  <cp:revision>36</cp:revision>
  <dcterms:created xsi:type="dcterms:W3CDTF">2024-05-14T01:47:53Z</dcterms:created>
  <dcterms:modified xsi:type="dcterms:W3CDTF">2024-09-16T20:00:51Z</dcterms:modified>
</cp:coreProperties>
</file>